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0"/>
  </p:notesMasterIdLst>
  <p:sldIdLst>
    <p:sldId id="272" r:id="rId2"/>
    <p:sldId id="273" r:id="rId3"/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</p:sldIdLst>
  <p:sldSz cx="8999538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E64AD2B-AD14-4588-B017-AC051AE21A93}" v="351" dt="2021-01-26T21:38:53.46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1"/>
    <p:restoredTop sz="94654"/>
  </p:normalViewPr>
  <p:slideViewPr>
    <p:cSldViewPr snapToGrid="0">
      <p:cViewPr varScale="1">
        <p:scale>
          <a:sx n="98" d="100"/>
          <a:sy n="98" d="100"/>
        </p:scale>
        <p:origin x="1104" y="77"/>
      </p:cViewPr>
      <p:guideLst>
        <p:guide orient="horz" pos="1701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543C06-765F-4A31-9C6D-0E59331B52B0}" type="datetimeFigureOut">
              <a:rPr lang="en-SG" smtClean="0"/>
              <a:t>27/1/2021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1143000"/>
            <a:ext cx="5143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96EF40-D991-4E5A-88A4-CE1A32D1301F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89624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1pPr>
    <a:lvl2pPr marL="345597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2pPr>
    <a:lvl3pPr marL="691195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3pPr>
    <a:lvl4pPr marL="1036792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4pPr>
    <a:lvl5pPr marL="1382390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5pPr>
    <a:lvl6pPr marL="1727987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6pPr>
    <a:lvl7pPr marL="2073585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7pPr>
    <a:lvl8pPr marL="2419182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8pPr>
    <a:lvl9pPr marL="2764780" algn="l" defTabSz="691195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011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3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9023472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229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8330328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232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3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8178107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245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4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05066664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367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0431485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376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6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003945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405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7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8083714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431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8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522230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024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4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001476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061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438147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065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6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642894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857250" y="1143000"/>
            <a:ext cx="51435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sz="900" dirty="0">
                <a:cs typeface="Calibri"/>
              </a:rPr>
              <a:t>ID182</a:t>
            </a:r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7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413758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187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8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842386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191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9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2450792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194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0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98692764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900" dirty="0">
                <a:cs typeface="Calibri"/>
              </a:rPr>
              <a:t>ID226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96EF40-D991-4E5A-88A4-CE1A32D1301F}" type="slidenum">
              <a:rPr lang="en-SG" smtClean="0"/>
              <a:t>1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122329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24942" y="883861"/>
            <a:ext cx="6749654" cy="1880235"/>
          </a:xfrm>
        </p:spPr>
        <p:txBody>
          <a:bodyPr anchor="b"/>
          <a:lstStyle>
            <a:lvl1pPr algn="ctr">
              <a:defRPr sz="442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2836605"/>
            <a:ext cx="6749654" cy="1303913"/>
          </a:xfrm>
        </p:spPr>
        <p:txBody>
          <a:bodyPr/>
          <a:lstStyle>
            <a:lvl1pPr marL="0" indent="0" algn="ctr">
              <a:buNone/>
              <a:defRPr sz="1772"/>
            </a:lvl1pPr>
            <a:lvl2pPr marL="337505" indent="0" algn="ctr">
              <a:buNone/>
              <a:defRPr sz="1476"/>
            </a:lvl2pPr>
            <a:lvl3pPr marL="675010" indent="0" algn="ctr">
              <a:buNone/>
              <a:defRPr sz="1329"/>
            </a:lvl3pPr>
            <a:lvl4pPr marL="1012515" indent="0" algn="ctr">
              <a:buNone/>
              <a:defRPr sz="1181"/>
            </a:lvl4pPr>
            <a:lvl5pPr marL="1350020" indent="0" algn="ctr">
              <a:buNone/>
              <a:defRPr sz="1181"/>
            </a:lvl5pPr>
            <a:lvl6pPr marL="1687525" indent="0" algn="ctr">
              <a:buNone/>
              <a:defRPr sz="1181"/>
            </a:lvl6pPr>
            <a:lvl7pPr marL="2025030" indent="0" algn="ctr">
              <a:buNone/>
              <a:defRPr sz="1181"/>
            </a:lvl7pPr>
            <a:lvl8pPr marL="2362535" indent="0" algn="ctr">
              <a:buNone/>
              <a:defRPr sz="1181"/>
            </a:lvl8pPr>
            <a:lvl9pPr marL="2700040" indent="0" algn="ctr">
              <a:buNone/>
              <a:defRPr sz="118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2479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3940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287536"/>
            <a:ext cx="1940525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8" y="287536"/>
            <a:ext cx="5709082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6676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5487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346419"/>
            <a:ext cx="7762102" cy="2246530"/>
          </a:xfrm>
        </p:spPr>
        <p:txBody>
          <a:bodyPr anchor="b"/>
          <a:lstStyle>
            <a:lvl1pPr>
              <a:defRPr sz="442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3614203"/>
            <a:ext cx="7762102" cy="1181397"/>
          </a:xfrm>
        </p:spPr>
        <p:txBody>
          <a:bodyPr/>
          <a:lstStyle>
            <a:lvl1pPr marL="0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1pPr>
            <a:lvl2pPr marL="337505" indent="0">
              <a:buNone/>
              <a:defRPr sz="1476">
                <a:solidFill>
                  <a:schemeClr val="tx1">
                    <a:tint val="75000"/>
                  </a:schemeClr>
                </a:solidFill>
              </a:defRPr>
            </a:lvl2pPr>
            <a:lvl3pPr marL="675010" indent="0">
              <a:buNone/>
              <a:defRPr sz="1329">
                <a:solidFill>
                  <a:schemeClr val="tx1">
                    <a:tint val="75000"/>
                  </a:schemeClr>
                </a:solidFill>
              </a:defRPr>
            </a:lvl3pPr>
            <a:lvl4pPr marL="1012515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4pPr>
            <a:lvl5pPr marL="1350020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5pPr>
            <a:lvl6pPr marL="1687525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6pPr>
            <a:lvl7pPr marL="2025030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7pPr>
            <a:lvl8pPr marL="2362535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8pPr>
            <a:lvl9pPr marL="2700040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179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437680"/>
            <a:ext cx="3824804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437680"/>
            <a:ext cx="3824804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92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287536"/>
            <a:ext cx="7762102" cy="10438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323916"/>
            <a:ext cx="3807226" cy="648831"/>
          </a:xfrm>
        </p:spPr>
        <p:txBody>
          <a:bodyPr anchor="b"/>
          <a:lstStyle>
            <a:lvl1pPr marL="0" indent="0">
              <a:buNone/>
              <a:defRPr sz="1772" b="1"/>
            </a:lvl1pPr>
            <a:lvl2pPr marL="337505" indent="0">
              <a:buNone/>
              <a:defRPr sz="1476" b="1"/>
            </a:lvl2pPr>
            <a:lvl3pPr marL="675010" indent="0">
              <a:buNone/>
              <a:defRPr sz="1329" b="1"/>
            </a:lvl3pPr>
            <a:lvl4pPr marL="1012515" indent="0">
              <a:buNone/>
              <a:defRPr sz="1181" b="1"/>
            </a:lvl4pPr>
            <a:lvl5pPr marL="1350020" indent="0">
              <a:buNone/>
              <a:defRPr sz="1181" b="1"/>
            </a:lvl5pPr>
            <a:lvl6pPr marL="1687525" indent="0">
              <a:buNone/>
              <a:defRPr sz="1181" b="1"/>
            </a:lvl6pPr>
            <a:lvl7pPr marL="2025030" indent="0">
              <a:buNone/>
              <a:defRPr sz="1181" b="1"/>
            </a:lvl7pPr>
            <a:lvl8pPr marL="2362535" indent="0">
              <a:buNone/>
              <a:defRPr sz="1181" b="1"/>
            </a:lvl8pPr>
            <a:lvl9pPr marL="2700040" indent="0">
              <a:buNone/>
              <a:defRPr sz="118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1972747"/>
            <a:ext cx="3807226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6" y="1323916"/>
            <a:ext cx="3825976" cy="648831"/>
          </a:xfrm>
        </p:spPr>
        <p:txBody>
          <a:bodyPr anchor="b"/>
          <a:lstStyle>
            <a:lvl1pPr marL="0" indent="0">
              <a:buNone/>
              <a:defRPr sz="1772" b="1"/>
            </a:lvl1pPr>
            <a:lvl2pPr marL="337505" indent="0">
              <a:buNone/>
              <a:defRPr sz="1476" b="1"/>
            </a:lvl2pPr>
            <a:lvl3pPr marL="675010" indent="0">
              <a:buNone/>
              <a:defRPr sz="1329" b="1"/>
            </a:lvl3pPr>
            <a:lvl4pPr marL="1012515" indent="0">
              <a:buNone/>
              <a:defRPr sz="1181" b="1"/>
            </a:lvl4pPr>
            <a:lvl5pPr marL="1350020" indent="0">
              <a:buNone/>
              <a:defRPr sz="1181" b="1"/>
            </a:lvl5pPr>
            <a:lvl6pPr marL="1687525" indent="0">
              <a:buNone/>
              <a:defRPr sz="1181" b="1"/>
            </a:lvl6pPr>
            <a:lvl7pPr marL="2025030" indent="0">
              <a:buNone/>
              <a:defRPr sz="1181" b="1"/>
            </a:lvl7pPr>
            <a:lvl8pPr marL="2362535" indent="0">
              <a:buNone/>
              <a:defRPr sz="1181" b="1"/>
            </a:lvl8pPr>
            <a:lvl9pPr marL="2700040" indent="0">
              <a:buNone/>
              <a:defRPr sz="118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6" y="1972747"/>
            <a:ext cx="3825976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3313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6707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5186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360045"/>
            <a:ext cx="2902585" cy="1260158"/>
          </a:xfrm>
        </p:spPr>
        <p:txBody>
          <a:bodyPr anchor="b"/>
          <a:lstStyle>
            <a:lvl1pPr>
              <a:defRPr sz="236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777597"/>
            <a:ext cx="4556016" cy="3837980"/>
          </a:xfrm>
        </p:spPr>
        <p:txBody>
          <a:bodyPr/>
          <a:lstStyle>
            <a:lvl1pPr>
              <a:defRPr sz="2362"/>
            </a:lvl1pPr>
            <a:lvl2pPr>
              <a:defRPr sz="2067"/>
            </a:lvl2pPr>
            <a:lvl3pPr>
              <a:defRPr sz="1772"/>
            </a:lvl3pPr>
            <a:lvl4pPr>
              <a:defRPr sz="1476"/>
            </a:lvl4pPr>
            <a:lvl5pPr>
              <a:defRPr sz="1476"/>
            </a:lvl5pPr>
            <a:lvl6pPr>
              <a:defRPr sz="1476"/>
            </a:lvl6pPr>
            <a:lvl7pPr>
              <a:defRPr sz="1476"/>
            </a:lvl7pPr>
            <a:lvl8pPr>
              <a:defRPr sz="1476"/>
            </a:lvl8pPr>
            <a:lvl9pPr>
              <a:defRPr sz="147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1620202"/>
            <a:ext cx="2902585" cy="3001626"/>
          </a:xfrm>
        </p:spPr>
        <p:txBody>
          <a:bodyPr/>
          <a:lstStyle>
            <a:lvl1pPr marL="0" indent="0">
              <a:buNone/>
              <a:defRPr sz="1181"/>
            </a:lvl1pPr>
            <a:lvl2pPr marL="337505" indent="0">
              <a:buNone/>
              <a:defRPr sz="1033"/>
            </a:lvl2pPr>
            <a:lvl3pPr marL="675010" indent="0">
              <a:buNone/>
              <a:defRPr sz="886"/>
            </a:lvl3pPr>
            <a:lvl4pPr marL="1012515" indent="0">
              <a:buNone/>
              <a:defRPr sz="738"/>
            </a:lvl4pPr>
            <a:lvl5pPr marL="1350020" indent="0">
              <a:buNone/>
              <a:defRPr sz="738"/>
            </a:lvl5pPr>
            <a:lvl6pPr marL="1687525" indent="0">
              <a:buNone/>
              <a:defRPr sz="738"/>
            </a:lvl6pPr>
            <a:lvl7pPr marL="2025030" indent="0">
              <a:buNone/>
              <a:defRPr sz="738"/>
            </a:lvl7pPr>
            <a:lvl8pPr marL="2362535" indent="0">
              <a:buNone/>
              <a:defRPr sz="738"/>
            </a:lvl8pPr>
            <a:lvl9pPr marL="2700040" indent="0">
              <a:buNone/>
              <a:defRPr sz="7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6904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360045"/>
            <a:ext cx="2902585" cy="1260158"/>
          </a:xfrm>
        </p:spPr>
        <p:txBody>
          <a:bodyPr anchor="b"/>
          <a:lstStyle>
            <a:lvl1pPr>
              <a:defRPr sz="236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777597"/>
            <a:ext cx="4556016" cy="3837980"/>
          </a:xfrm>
        </p:spPr>
        <p:txBody>
          <a:bodyPr anchor="t"/>
          <a:lstStyle>
            <a:lvl1pPr marL="0" indent="0">
              <a:buNone/>
              <a:defRPr sz="2362"/>
            </a:lvl1pPr>
            <a:lvl2pPr marL="337505" indent="0">
              <a:buNone/>
              <a:defRPr sz="2067"/>
            </a:lvl2pPr>
            <a:lvl3pPr marL="675010" indent="0">
              <a:buNone/>
              <a:defRPr sz="1772"/>
            </a:lvl3pPr>
            <a:lvl4pPr marL="1012515" indent="0">
              <a:buNone/>
              <a:defRPr sz="1476"/>
            </a:lvl4pPr>
            <a:lvl5pPr marL="1350020" indent="0">
              <a:buNone/>
              <a:defRPr sz="1476"/>
            </a:lvl5pPr>
            <a:lvl6pPr marL="1687525" indent="0">
              <a:buNone/>
              <a:defRPr sz="1476"/>
            </a:lvl6pPr>
            <a:lvl7pPr marL="2025030" indent="0">
              <a:buNone/>
              <a:defRPr sz="1476"/>
            </a:lvl7pPr>
            <a:lvl8pPr marL="2362535" indent="0">
              <a:buNone/>
              <a:defRPr sz="1476"/>
            </a:lvl8pPr>
            <a:lvl9pPr marL="2700040" indent="0">
              <a:buNone/>
              <a:defRPr sz="147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1620202"/>
            <a:ext cx="2902585" cy="3001626"/>
          </a:xfrm>
        </p:spPr>
        <p:txBody>
          <a:bodyPr/>
          <a:lstStyle>
            <a:lvl1pPr marL="0" indent="0">
              <a:buNone/>
              <a:defRPr sz="1181"/>
            </a:lvl1pPr>
            <a:lvl2pPr marL="337505" indent="0">
              <a:buNone/>
              <a:defRPr sz="1033"/>
            </a:lvl2pPr>
            <a:lvl3pPr marL="675010" indent="0">
              <a:buNone/>
              <a:defRPr sz="886"/>
            </a:lvl3pPr>
            <a:lvl4pPr marL="1012515" indent="0">
              <a:buNone/>
              <a:defRPr sz="738"/>
            </a:lvl4pPr>
            <a:lvl5pPr marL="1350020" indent="0">
              <a:buNone/>
              <a:defRPr sz="738"/>
            </a:lvl5pPr>
            <a:lvl6pPr marL="1687525" indent="0">
              <a:buNone/>
              <a:defRPr sz="738"/>
            </a:lvl6pPr>
            <a:lvl7pPr marL="2025030" indent="0">
              <a:buNone/>
              <a:defRPr sz="738"/>
            </a:lvl7pPr>
            <a:lvl8pPr marL="2362535" indent="0">
              <a:buNone/>
              <a:defRPr sz="738"/>
            </a:lvl8pPr>
            <a:lvl9pPr marL="2700040" indent="0">
              <a:buNone/>
              <a:defRPr sz="7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635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287536"/>
            <a:ext cx="7762102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437680"/>
            <a:ext cx="7762102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5005626"/>
            <a:ext cx="20248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BE9A3-D1DF-4EAA-AA68-76D49C962708}" type="datetimeFigureOut">
              <a:rPr lang="de-DE" smtClean="0"/>
              <a:t>27.01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5005626"/>
            <a:ext cx="3037344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5005626"/>
            <a:ext cx="20248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CA659-08EF-4AC7-996B-CE434F0C1CA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6723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75010" rtl="0" eaLnBrk="1" latinLnBrk="0" hangingPunct="1">
        <a:lnSpc>
          <a:spcPct val="90000"/>
        </a:lnSpc>
        <a:spcBef>
          <a:spcPct val="0"/>
        </a:spcBef>
        <a:buNone/>
        <a:defRPr sz="32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753" indent="-168753" algn="l" defTabSz="67501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067" kern="1200">
          <a:solidFill>
            <a:schemeClr val="tx1"/>
          </a:solidFill>
          <a:latin typeface="+mn-lt"/>
          <a:ea typeface="+mn-ea"/>
          <a:cs typeface="+mn-cs"/>
        </a:defRPr>
      </a:lvl1pPr>
      <a:lvl2pPr marL="506258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43763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476" kern="1200">
          <a:solidFill>
            <a:schemeClr val="tx1"/>
          </a:solidFill>
          <a:latin typeface="+mn-lt"/>
          <a:ea typeface="+mn-ea"/>
          <a:cs typeface="+mn-cs"/>
        </a:defRPr>
      </a:lvl3pPr>
      <a:lvl4pPr marL="1181268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4pPr>
      <a:lvl5pPr marL="1518773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5pPr>
      <a:lvl6pPr marL="1856278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6pPr>
      <a:lvl7pPr marL="2193783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7pPr>
      <a:lvl8pPr marL="2531288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8pPr>
      <a:lvl9pPr marL="2868793" indent="-168753" algn="l" defTabSz="675010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1pPr>
      <a:lvl2pPr marL="337505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2pPr>
      <a:lvl3pPr marL="675010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3pPr>
      <a:lvl4pPr marL="1012515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4pPr>
      <a:lvl5pPr marL="1350020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5pPr>
      <a:lvl6pPr marL="1687525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6pPr>
      <a:lvl7pPr marL="2025030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7pPr>
      <a:lvl8pPr marL="2362535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8pPr>
      <a:lvl9pPr marL="2700040" algn="l" defTabSz="675010" rtl="0" eaLnBrk="1" latinLnBrk="0" hangingPunct="1">
        <a:defRPr sz="132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ubburaj@sutd.edu.sg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8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A3B82B8-C2F3-A34B-B802-9BE682D48943}"/>
              </a:ext>
            </a:extLst>
          </p:cNvPr>
          <p:cNvSpPr/>
          <p:nvPr/>
        </p:nvSpPr>
        <p:spPr>
          <a:xfrm>
            <a:off x="72359" y="233180"/>
            <a:ext cx="8708923" cy="45550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on of Incidental Osteoporotic Fractures at the Vertebral-Specific Level Using 3D Non-Linear Finite Element Parameters Derived from Routine Abdominal MDCT</a:t>
            </a:r>
          </a:p>
          <a:p>
            <a:pPr algn="just"/>
            <a:endParaRPr lang="en-SG" sz="12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ngyu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Yeung*, BE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thin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anohar Rayudu*, MEng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aximilian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öffler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²,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jany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kuboyina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Sc², Egon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urian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², Nico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ollmann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, PhD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3,4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ichael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eckmeyer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, MSc², Tobias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reve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5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Jan S.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irschke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²,3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rupppasamy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bburaj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PhD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6**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homas Baum, MD</a:t>
            </a:r>
            <a:r>
              <a:rPr lang="en-US" sz="1200" b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endParaRPr lang="en-SG" sz="12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endParaRPr lang="en-US" sz="1050" baseline="3000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 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gineering Product Development (EPD) Pillar, Singapore University of Technology and Design (SUTD), Singapore 487372.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partment of Diagnostic and Interventional Neuroradiology,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linikum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chts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r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ar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School of Medicine, Technical University of Munich,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maninger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tr. 22, 81675 Munich, Germany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de-DE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de-DE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UM-Neuroimaging Center, Klinikum rechts der Isar, Technical University </a:t>
            </a:r>
            <a:r>
              <a:rPr lang="de-DE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lang="de-DE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de-DE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nich</a:t>
            </a:r>
            <a:r>
              <a:rPr lang="de-DE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de-DE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nich</a:t>
            </a:r>
            <a:r>
              <a:rPr lang="de-DE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Germany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partment of Diagnostic and Interventional Radiology, University Hospital Ulm, Albert-Einstein-Allee 23, 89081 Ulm, Germany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partment of Neurosurgery, Ludwig-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ximilians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University,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chioninistraße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15, 81377 Munich, Germany</a:t>
            </a:r>
          </a:p>
          <a:p>
            <a:pPr algn="just"/>
            <a:r>
              <a:rPr lang="en-US" sz="105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hangi General Hospital, 2 </a:t>
            </a:r>
            <a:r>
              <a:rPr lang="en-US" sz="105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mei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treet 3, Singapore 529889</a:t>
            </a:r>
          </a:p>
          <a:p>
            <a:pPr algn="just"/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 Authors equally contributed to this work.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endParaRPr lang="en-US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*	Correspondence: 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hlinkClick r:id="rId2"/>
              </a:rPr>
              <a:t>Subburaj@sutd.edu.sg</a:t>
            </a: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Phone: +65 6499 4897 </a:t>
            </a:r>
            <a:endParaRPr lang="en-SG" sz="1050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14656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5357919E-88EB-45C8-AD96-914CF5598100}"/>
              </a:ext>
            </a:extLst>
          </p:cNvPr>
          <p:cNvGrpSpPr/>
          <p:nvPr/>
        </p:nvGrpSpPr>
        <p:grpSpPr>
          <a:xfrm>
            <a:off x="4722689" y="1049395"/>
            <a:ext cx="4250572" cy="3638585"/>
            <a:chOff x="8429625" y="2709047"/>
            <a:chExt cx="1933575" cy="1609724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429625" y="2709047"/>
              <a:ext cx="1933575" cy="160972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4E9ECE9-D937-4C81-9DE0-FF617F4A9809}"/>
                </a:ext>
              </a:extLst>
            </p:cNvPr>
            <p:cNvSpPr txBox="1"/>
            <p:nvPr/>
          </p:nvSpPr>
          <p:spPr>
            <a:xfrm>
              <a:off x="8665934" y="3854367"/>
              <a:ext cx="409153" cy="180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5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2A2CFD89-7288-4865-9E69-3B3C076B3DF0}"/>
              </a:ext>
            </a:extLst>
          </p:cNvPr>
          <p:cNvGrpSpPr/>
          <p:nvPr/>
        </p:nvGrpSpPr>
        <p:grpSpPr>
          <a:xfrm>
            <a:off x="79297" y="1050126"/>
            <a:ext cx="4577704" cy="3649907"/>
            <a:chOff x="3143250" y="2757487"/>
            <a:chExt cx="1781176" cy="13430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143250" y="2757487"/>
              <a:ext cx="1781176" cy="134302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0831DD7-8096-44CD-ADCF-0951C169D931}"/>
                </a:ext>
              </a:extLst>
            </p:cNvPr>
            <p:cNvSpPr txBox="1"/>
            <p:nvPr/>
          </p:nvSpPr>
          <p:spPr>
            <a:xfrm>
              <a:off x="3313716" y="3658657"/>
              <a:ext cx="446627" cy="1189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5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277667F6-6DF8-D34B-993E-B6A5CBFDB8F2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8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DE9DB1F-3413-F940-A6B9-B2DABB2694B2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F81C7A8-2D30-A64F-8C57-A6CAEFA83F8B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7068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59565C1A-CE66-46C4-887D-7FF9FE6054BB}"/>
              </a:ext>
            </a:extLst>
          </p:cNvPr>
          <p:cNvGrpSpPr/>
          <p:nvPr/>
        </p:nvGrpSpPr>
        <p:grpSpPr>
          <a:xfrm>
            <a:off x="4595442" y="1160969"/>
            <a:ext cx="3399292" cy="3706521"/>
            <a:chOff x="6705600" y="2514599"/>
            <a:chExt cx="1609725" cy="158115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705600" y="2514599"/>
              <a:ext cx="1609725" cy="158115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6FE1522-DE7E-411A-9356-0554FDD83053}"/>
                </a:ext>
              </a:extLst>
            </p:cNvPr>
            <p:cNvSpPr txBox="1"/>
            <p:nvPr/>
          </p:nvSpPr>
          <p:spPr>
            <a:xfrm>
              <a:off x="6929667" y="3191107"/>
              <a:ext cx="432575" cy="1774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78FD4854-D128-43DB-B899-F127815E5FBB}"/>
              </a:ext>
            </a:extLst>
          </p:cNvPr>
          <p:cNvGrpSpPr/>
          <p:nvPr/>
        </p:nvGrpSpPr>
        <p:grpSpPr>
          <a:xfrm>
            <a:off x="782624" y="1160967"/>
            <a:ext cx="3568725" cy="3717842"/>
            <a:chOff x="3962400" y="2514599"/>
            <a:chExt cx="1695450" cy="17811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962400" y="2514599"/>
              <a:ext cx="1695450" cy="17811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5E4A512-DC45-45FE-A58A-7C77019456AB}"/>
                </a:ext>
              </a:extLst>
            </p:cNvPr>
            <p:cNvSpPr txBox="1"/>
            <p:nvPr/>
          </p:nvSpPr>
          <p:spPr>
            <a:xfrm>
              <a:off x="4119684" y="3208145"/>
              <a:ext cx="440107" cy="19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F7265BEE-0227-3840-8F23-F85471340FF9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9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674B266-3C88-FC47-8D81-467F6BB6B49E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733E091-66F9-644E-8D05-B2F6A9DA9B26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1175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-776078" y="-445243"/>
            <a:ext cx="449162" cy="301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229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7CB782A-46EA-443E-BD59-5A7693D96E7F}"/>
              </a:ext>
            </a:extLst>
          </p:cNvPr>
          <p:cNvGrpSpPr/>
          <p:nvPr/>
        </p:nvGrpSpPr>
        <p:grpSpPr>
          <a:xfrm>
            <a:off x="4687134" y="1226420"/>
            <a:ext cx="3140832" cy="3957152"/>
            <a:chOff x="7362825" y="2371724"/>
            <a:chExt cx="1831114" cy="26003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362825" y="2371724"/>
              <a:ext cx="1831114" cy="260032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8AA0BEF-FBE5-4A5E-9E51-619ADD88C05C}"/>
                </a:ext>
              </a:extLst>
            </p:cNvPr>
            <p:cNvSpPr txBox="1"/>
            <p:nvPr/>
          </p:nvSpPr>
          <p:spPr>
            <a:xfrm>
              <a:off x="7621517" y="3054340"/>
              <a:ext cx="638564" cy="2917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B136FD6-1B51-4909-83B8-5BEB358388FC}"/>
                </a:ext>
              </a:extLst>
            </p:cNvPr>
            <p:cNvSpPr txBox="1"/>
            <p:nvPr/>
          </p:nvSpPr>
          <p:spPr>
            <a:xfrm>
              <a:off x="7582428" y="3375742"/>
              <a:ext cx="775764" cy="2917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EAE2906-805D-4B6E-A225-A146C4937333}"/>
                </a:ext>
              </a:extLst>
            </p:cNvPr>
            <p:cNvSpPr txBox="1"/>
            <p:nvPr/>
          </p:nvSpPr>
          <p:spPr>
            <a:xfrm>
              <a:off x="7509207" y="3669642"/>
              <a:ext cx="775764" cy="2917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6AD0790-E435-46E9-849F-92414F28845D}"/>
              </a:ext>
            </a:extLst>
          </p:cNvPr>
          <p:cNvGrpSpPr/>
          <p:nvPr/>
        </p:nvGrpSpPr>
        <p:grpSpPr>
          <a:xfrm>
            <a:off x="752543" y="1214076"/>
            <a:ext cx="3576174" cy="3966929"/>
            <a:chOff x="3286125" y="2633660"/>
            <a:chExt cx="1457325" cy="2076451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286125" y="2633660"/>
              <a:ext cx="1457325" cy="2076451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733F7C6-05DC-470B-8F4C-6FECF09D8299}"/>
                </a:ext>
              </a:extLst>
            </p:cNvPr>
            <p:cNvSpPr txBox="1"/>
            <p:nvPr/>
          </p:nvSpPr>
          <p:spPr>
            <a:xfrm>
              <a:off x="3370620" y="3196261"/>
              <a:ext cx="359228" cy="232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68EFB83-BA16-42A1-9870-C4BABF3AD113}"/>
                </a:ext>
              </a:extLst>
            </p:cNvPr>
            <p:cNvSpPr txBox="1"/>
            <p:nvPr/>
          </p:nvSpPr>
          <p:spPr>
            <a:xfrm>
              <a:off x="3354325" y="3452141"/>
              <a:ext cx="348778" cy="232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F35D97A-1E1E-4852-A116-7B6DA9EE4D03}"/>
                </a:ext>
              </a:extLst>
            </p:cNvPr>
            <p:cNvSpPr txBox="1"/>
            <p:nvPr/>
          </p:nvSpPr>
          <p:spPr>
            <a:xfrm>
              <a:off x="3319085" y="3775232"/>
              <a:ext cx="317925" cy="232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383C4479-AC24-B245-99B0-76F4560DB8AE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0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9817A8A-26E7-1E44-8121-6FA88F840086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446BBF5-7B49-EF4D-86BC-AEB9885F7EB2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15894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239C91A6-DE14-4270-A8F0-4884BE6FFA36}"/>
              </a:ext>
            </a:extLst>
          </p:cNvPr>
          <p:cNvGrpSpPr/>
          <p:nvPr/>
        </p:nvGrpSpPr>
        <p:grpSpPr>
          <a:xfrm>
            <a:off x="4568832" y="944138"/>
            <a:ext cx="3654262" cy="3604618"/>
            <a:chOff x="5838825" y="2228850"/>
            <a:chExt cx="1283353" cy="131445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838825" y="2228850"/>
              <a:ext cx="1283353" cy="131445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70C5C28-8320-4121-A357-4342F3BB564F}"/>
                </a:ext>
              </a:extLst>
            </p:cNvPr>
            <p:cNvSpPr txBox="1"/>
            <p:nvPr/>
          </p:nvSpPr>
          <p:spPr>
            <a:xfrm>
              <a:off x="6018450" y="2815324"/>
              <a:ext cx="244967" cy="147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86A4C67-4B12-4112-AAA1-7B2BE0210A8A}"/>
              </a:ext>
            </a:extLst>
          </p:cNvPr>
          <p:cNvGrpSpPr/>
          <p:nvPr/>
        </p:nvGrpSpPr>
        <p:grpSpPr>
          <a:xfrm>
            <a:off x="478078" y="944138"/>
            <a:ext cx="3544996" cy="3604618"/>
            <a:chOff x="3122142" y="2228850"/>
            <a:chExt cx="868834" cy="10953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124200" y="2228850"/>
              <a:ext cx="866776" cy="10953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1ED4D85-8539-47FE-8E33-E1B6CC712747}"/>
                </a:ext>
              </a:extLst>
            </p:cNvPr>
            <p:cNvSpPr txBox="1"/>
            <p:nvPr/>
          </p:nvSpPr>
          <p:spPr>
            <a:xfrm>
              <a:off x="3122142" y="2698414"/>
              <a:ext cx="207379" cy="1229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F6617654-7E21-B549-9DC5-6A2B22F9097C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1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1351798-233F-2741-BBD7-7C7CA715F43A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E48AE52-A73F-D342-8D3C-8B6E794907F7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48329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F0C8CA97-43AE-4897-A134-BDEBB24EB975}"/>
              </a:ext>
            </a:extLst>
          </p:cNvPr>
          <p:cNvGrpSpPr/>
          <p:nvPr/>
        </p:nvGrpSpPr>
        <p:grpSpPr>
          <a:xfrm>
            <a:off x="4235271" y="1231629"/>
            <a:ext cx="3348617" cy="3797095"/>
            <a:chOff x="7829551" y="2381250"/>
            <a:chExt cx="1438276" cy="146685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829551" y="2381250"/>
              <a:ext cx="1438276" cy="146685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FCDB8C7-7665-4D15-961D-37719D59F692}"/>
                </a:ext>
              </a:extLst>
            </p:cNvPr>
            <p:cNvSpPr txBox="1"/>
            <p:nvPr/>
          </p:nvSpPr>
          <p:spPr>
            <a:xfrm>
              <a:off x="8055542" y="2988240"/>
              <a:ext cx="434067" cy="164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75D6DE85-40A9-4735-96B9-AF36F370E49F}"/>
              </a:ext>
            </a:extLst>
          </p:cNvPr>
          <p:cNvGrpSpPr/>
          <p:nvPr/>
        </p:nvGrpSpPr>
        <p:grpSpPr>
          <a:xfrm>
            <a:off x="538612" y="1222045"/>
            <a:ext cx="3439179" cy="3808417"/>
            <a:chOff x="3067050" y="2143125"/>
            <a:chExt cx="1438276" cy="1771650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067050" y="2143125"/>
              <a:ext cx="1438276" cy="177165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22A94D0-C768-444F-8FE4-264F20759B7E}"/>
                </a:ext>
              </a:extLst>
            </p:cNvPr>
            <p:cNvSpPr txBox="1"/>
            <p:nvPr/>
          </p:nvSpPr>
          <p:spPr>
            <a:xfrm>
              <a:off x="3089066" y="2835000"/>
              <a:ext cx="361808" cy="198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9EE603BF-E759-4282-B864-CC8362922F29}"/>
              </a:ext>
            </a:extLst>
          </p:cNvPr>
          <p:cNvSpPr txBox="1"/>
          <p:nvPr/>
        </p:nvSpPr>
        <p:spPr>
          <a:xfrm>
            <a:off x="4732704" y="2309922"/>
            <a:ext cx="1010602" cy="3231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500" dirty="0">
                <a:solidFill>
                  <a:schemeClr val="bg1"/>
                </a:solidFill>
                <a:latin typeface="Arial"/>
                <a:cs typeface="Arial"/>
              </a:rPr>
              <a:t>T11</a:t>
            </a:r>
            <a:endParaRPr lang="en-SG" sz="1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AFAAB6-E8F1-4C19-A407-CA0275952DF7}"/>
              </a:ext>
            </a:extLst>
          </p:cNvPr>
          <p:cNvSpPr txBox="1"/>
          <p:nvPr/>
        </p:nvSpPr>
        <p:spPr>
          <a:xfrm>
            <a:off x="884705" y="2060834"/>
            <a:ext cx="1010602" cy="3231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500" dirty="0">
                <a:solidFill>
                  <a:schemeClr val="bg1"/>
                </a:solidFill>
                <a:latin typeface="Arial"/>
                <a:cs typeface="Arial"/>
              </a:rPr>
              <a:t>T11</a:t>
            </a:r>
            <a:endParaRPr lang="en-SG" sz="1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842AF72-7EA2-407A-9128-61C3C9C5F8C7}"/>
              </a:ext>
            </a:extLst>
          </p:cNvPr>
          <p:cNvSpPr txBox="1"/>
          <p:nvPr/>
        </p:nvSpPr>
        <p:spPr>
          <a:xfrm>
            <a:off x="4733591" y="1721169"/>
            <a:ext cx="1010602" cy="3231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500" dirty="0">
                <a:solidFill>
                  <a:schemeClr val="bg1"/>
                </a:solidFill>
                <a:latin typeface="Arial"/>
                <a:cs typeface="Arial"/>
              </a:rPr>
              <a:t>T10</a:t>
            </a:r>
            <a:endParaRPr lang="en-SG" sz="1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DCEC83-79B0-4FE2-8D7B-4F467252D02D}"/>
              </a:ext>
            </a:extLst>
          </p:cNvPr>
          <p:cNvSpPr txBox="1"/>
          <p:nvPr/>
        </p:nvSpPr>
        <p:spPr>
          <a:xfrm>
            <a:off x="885593" y="1494725"/>
            <a:ext cx="1010602" cy="3231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500" dirty="0">
                <a:solidFill>
                  <a:schemeClr val="bg1"/>
                </a:solidFill>
                <a:latin typeface="Arial"/>
                <a:cs typeface="Arial"/>
              </a:rPr>
              <a:t>T10</a:t>
            </a:r>
            <a:endParaRPr lang="en-SG" sz="1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039A7CA-118C-4D4D-8E83-073C02392316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2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D33B7BA-2B7C-184C-B28D-7B74A1243225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E27D981-DBA5-AC4B-AB45-E7FF053EC930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663726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2F6B9E0A-08CE-4932-9C0C-937232D3D80B}"/>
              </a:ext>
            </a:extLst>
          </p:cNvPr>
          <p:cNvGrpSpPr/>
          <p:nvPr/>
        </p:nvGrpSpPr>
        <p:grpSpPr>
          <a:xfrm>
            <a:off x="4500911" y="1207295"/>
            <a:ext cx="3348617" cy="3785773"/>
            <a:chOff x="7557174" y="1978304"/>
            <a:chExt cx="1602259" cy="205740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57174" y="1978304"/>
              <a:ext cx="1602259" cy="20574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8D12459-6991-4105-AAD4-A0D92DC956D6}"/>
                </a:ext>
              </a:extLst>
            </p:cNvPr>
            <p:cNvSpPr txBox="1"/>
            <p:nvPr/>
          </p:nvSpPr>
          <p:spPr>
            <a:xfrm>
              <a:off x="7558026" y="2776273"/>
              <a:ext cx="462969" cy="2308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396F8CB3-0753-46ED-AA6E-C577938BA26A}"/>
              </a:ext>
            </a:extLst>
          </p:cNvPr>
          <p:cNvGrpSpPr/>
          <p:nvPr/>
        </p:nvGrpSpPr>
        <p:grpSpPr>
          <a:xfrm>
            <a:off x="357489" y="1207295"/>
            <a:ext cx="3507100" cy="3785773"/>
            <a:chOff x="3116301" y="1971675"/>
            <a:chExt cx="1674774" cy="17811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116301" y="1971675"/>
              <a:ext cx="1674774" cy="17811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063931A-E51B-4446-885B-37B9F038E1F3}"/>
                </a:ext>
              </a:extLst>
            </p:cNvPr>
            <p:cNvSpPr txBox="1"/>
            <p:nvPr/>
          </p:nvSpPr>
          <p:spPr>
            <a:xfrm>
              <a:off x="3262527" y="2664150"/>
              <a:ext cx="462969" cy="19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A9DEF540-A598-ED4C-8E2D-E784D5990CCA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3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F5B83C6-159F-994B-8E8E-BBB23B98DFB6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3DAB135-322B-1643-A5E2-11CC11F0B91C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215860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11948B70-A79B-441A-BF29-9831375B852B}"/>
              </a:ext>
            </a:extLst>
          </p:cNvPr>
          <p:cNvGrpSpPr/>
          <p:nvPr/>
        </p:nvGrpSpPr>
        <p:grpSpPr>
          <a:xfrm>
            <a:off x="844256" y="939739"/>
            <a:ext cx="3416539" cy="3966928"/>
            <a:chOff x="3352800" y="2085975"/>
            <a:chExt cx="1162050" cy="130492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352800" y="2085975"/>
              <a:ext cx="1162050" cy="130492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54EE2A3-C5D0-49ED-9FD7-1337B8F771AA}"/>
                </a:ext>
              </a:extLst>
            </p:cNvPr>
            <p:cNvSpPr txBox="1"/>
            <p:nvPr/>
          </p:nvSpPr>
          <p:spPr>
            <a:xfrm>
              <a:off x="3439062" y="2666917"/>
              <a:ext cx="236600" cy="1464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9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3486B8F-5523-4A47-A6FA-DDFC9D4466FE}"/>
              </a:ext>
            </a:extLst>
          </p:cNvPr>
          <p:cNvGrpSpPr/>
          <p:nvPr/>
        </p:nvGrpSpPr>
        <p:grpSpPr>
          <a:xfrm>
            <a:off x="4359335" y="939739"/>
            <a:ext cx="3597660" cy="3966927"/>
            <a:chOff x="8382000" y="1885950"/>
            <a:chExt cx="1524000" cy="17049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382000" y="1885950"/>
              <a:ext cx="1524000" cy="17049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E47B8F4-DEC8-4568-8845-7BD7878E794A}"/>
                </a:ext>
              </a:extLst>
            </p:cNvPr>
            <p:cNvSpPr txBox="1"/>
            <p:nvPr/>
          </p:nvSpPr>
          <p:spPr>
            <a:xfrm>
              <a:off x="8598017" y="2628212"/>
              <a:ext cx="324889" cy="191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9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D9BF03F7-1820-2044-B60D-4789BE6FF447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4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418EBAF-A8A9-AC43-AFEC-D462FB8F64B1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2439DD5-35EB-0442-981C-855A0EDB007E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68569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0D6280CF-613F-4477-9882-CE577C3835A4}"/>
              </a:ext>
            </a:extLst>
          </p:cNvPr>
          <p:cNvGrpSpPr/>
          <p:nvPr/>
        </p:nvGrpSpPr>
        <p:grpSpPr>
          <a:xfrm>
            <a:off x="4331110" y="903163"/>
            <a:ext cx="3688222" cy="4306592"/>
            <a:chOff x="8264994" y="1476375"/>
            <a:chExt cx="1364782" cy="24860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264994" y="1476375"/>
              <a:ext cx="1364782" cy="248602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61F33A9-869F-441A-A200-5093E6872B24}"/>
                </a:ext>
              </a:extLst>
            </p:cNvPr>
            <p:cNvSpPr txBox="1"/>
            <p:nvPr/>
          </p:nvSpPr>
          <p:spPr>
            <a:xfrm>
              <a:off x="8385760" y="2046338"/>
              <a:ext cx="333950" cy="278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4C88059-E69F-449D-97FA-F8173F629493}"/>
                </a:ext>
              </a:extLst>
            </p:cNvPr>
            <p:cNvSpPr txBox="1"/>
            <p:nvPr/>
          </p:nvSpPr>
          <p:spPr>
            <a:xfrm>
              <a:off x="8500244" y="3024282"/>
              <a:ext cx="275120" cy="278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9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5DD7BE34-67DB-4851-A469-910CD689D12F}"/>
              </a:ext>
            </a:extLst>
          </p:cNvPr>
          <p:cNvSpPr txBox="1"/>
          <p:nvPr/>
        </p:nvSpPr>
        <p:spPr>
          <a:xfrm>
            <a:off x="1405677" y="2592926"/>
            <a:ext cx="538950" cy="323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9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12EB379-1A3A-482E-BA96-133531B2E5C4}"/>
              </a:ext>
            </a:extLst>
          </p:cNvPr>
          <p:cNvGrpSpPr/>
          <p:nvPr/>
        </p:nvGrpSpPr>
        <p:grpSpPr>
          <a:xfrm>
            <a:off x="447845" y="903164"/>
            <a:ext cx="3778783" cy="4306591"/>
            <a:chOff x="2285999" y="1926084"/>
            <a:chExt cx="1047751" cy="1950663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8102CEA5-3D9D-4D9A-97A9-A0931F4692B5}"/>
                </a:ext>
              </a:extLst>
            </p:cNvPr>
            <p:cNvGrpSpPr/>
            <p:nvPr/>
          </p:nvGrpSpPr>
          <p:grpSpPr>
            <a:xfrm>
              <a:off x="2285999" y="1926084"/>
              <a:ext cx="1047751" cy="1950663"/>
              <a:chOff x="2285999" y="1926084"/>
              <a:chExt cx="1047751" cy="1950663"/>
            </a:xfrm>
          </p:grpSpPr>
          <p:pic>
            <p:nvPicPr>
              <p:cNvPr id="3" name="Grafik 2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2285999" y="1926084"/>
                <a:ext cx="1047751" cy="1950663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444F917-D99C-443B-8249-A9F4DFE07944}"/>
                  </a:ext>
                </a:extLst>
              </p:cNvPr>
              <p:cNvSpPr txBox="1"/>
              <p:nvPr/>
            </p:nvSpPr>
            <p:spPr>
              <a:xfrm>
                <a:off x="2421288" y="2430254"/>
                <a:ext cx="207107" cy="2188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SG" sz="1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5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3EE8FF-25D8-46CE-9E22-2B50503F4D2A}"/>
                </a:ext>
              </a:extLst>
            </p:cNvPr>
            <p:cNvSpPr txBox="1"/>
            <p:nvPr/>
          </p:nvSpPr>
          <p:spPr>
            <a:xfrm>
              <a:off x="2553065" y="3149631"/>
              <a:ext cx="207107" cy="2188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9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96611E08-7D3D-8642-94A6-084AF53DCAE0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5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2BC0A0C-243D-AC4B-BD73-C0756D5F165B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A855D8A-8481-8343-86A3-ACC2B4F61B71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93006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179597B-5F33-4D94-A6BA-3896B45D3A13}"/>
              </a:ext>
            </a:extLst>
          </p:cNvPr>
          <p:cNvGrpSpPr/>
          <p:nvPr/>
        </p:nvGrpSpPr>
        <p:grpSpPr>
          <a:xfrm>
            <a:off x="4617492" y="298598"/>
            <a:ext cx="3419216" cy="5026014"/>
            <a:chOff x="7715250" y="723898"/>
            <a:chExt cx="1447803" cy="36099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715250" y="723898"/>
              <a:ext cx="1447803" cy="360997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F3441AF-C912-473C-9433-F070A2F75460}"/>
                </a:ext>
              </a:extLst>
            </p:cNvPr>
            <p:cNvSpPr txBox="1"/>
            <p:nvPr/>
          </p:nvSpPr>
          <p:spPr>
            <a:xfrm>
              <a:off x="8152533" y="1354387"/>
              <a:ext cx="497636" cy="40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26168F3-AAD7-4D2D-8871-FD20FFF03298}"/>
                </a:ext>
              </a:extLst>
            </p:cNvPr>
            <p:cNvSpPr txBox="1"/>
            <p:nvPr/>
          </p:nvSpPr>
          <p:spPr>
            <a:xfrm>
              <a:off x="7849489" y="3071178"/>
              <a:ext cx="589483" cy="40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0FA9748-20BA-4A7D-AE35-723512DA0503}"/>
              </a:ext>
            </a:extLst>
          </p:cNvPr>
          <p:cNvGrpSpPr/>
          <p:nvPr/>
        </p:nvGrpSpPr>
        <p:grpSpPr>
          <a:xfrm>
            <a:off x="272482" y="301318"/>
            <a:ext cx="3886431" cy="5026587"/>
            <a:chOff x="4067174" y="1076324"/>
            <a:chExt cx="1362075" cy="290512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067174" y="1076324"/>
              <a:ext cx="1362075" cy="2905125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FA130E0-30AD-474C-969B-C8318AFE09AF}"/>
                </a:ext>
              </a:extLst>
            </p:cNvPr>
            <p:cNvSpPr txBox="1"/>
            <p:nvPr/>
          </p:nvSpPr>
          <p:spPr>
            <a:xfrm>
              <a:off x="4373774" y="1587296"/>
              <a:ext cx="497636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D61250A-9EBB-4CE3-AAA7-8E72083809E7}"/>
                </a:ext>
              </a:extLst>
            </p:cNvPr>
            <p:cNvSpPr txBox="1"/>
            <p:nvPr/>
          </p:nvSpPr>
          <p:spPr>
            <a:xfrm>
              <a:off x="4226384" y="2743395"/>
              <a:ext cx="58948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16D7C826-52FA-4D40-9C2F-DC30508613C4}"/>
              </a:ext>
            </a:extLst>
          </p:cNvPr>
          <p:cNvSpPr/>
          <p:nvPr/>
        </p:nvSpPr>
        <p:spPr>
          <a:xfrm>
            <a:off x="321058" y="-57241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6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62E9014-1990-864E-84B0-4846FCE16A80}"/>
              </a:ext>
            </a:extLst>
          </p:cNvPr>
          <p:cNvSpPr/>
          <p:nvPr/>
        </p:nvSpPr>
        <p:spPr>
          <a:xfrm>
            <a:off x="2215697" y="353612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C71A013-FC7B-C04F-A179-1028D50D7D7D}"/>
              </a:ext>
            </a:extLst>
          </p:cNvPr>
          <p:cNvSpPr/>
          <p:nvPr/>
        </p:nvSpPr>
        <p:spPr>
          <a:xfrm>
            <a:off x="6234776" y="353612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4625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D61A40D-7105-834C-89A7-814E567737B8}"/>
              </a:ext>
            </a:extLst>
          </p:cNvPr>
          <p:cNvSpPr/>
          <p:nvPr/>
        </p:nvSpPr>
        <p:spPr>
          <a:xfrm>
            <a:off x="589936" y="2056603"/>
            <a:ext cx="7647038" cy="12874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01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</a:p>
          <a:p>
            <a:pPr>
              <a:lnSpc>
                <a:spcPct val="150000"/>
              </a:lnSpc>
            </a:pP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gittal reformation of baseline (left) and follow-up (right) MDCT showing the incidental osteoporotic vertebral fractures at follow-up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55038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1768CABB-E139-47DF-AC8F-88E042224CEE}"/>
              </a:ext>
            </a:extLst>
          </p:cNvPr>
          <p:cNvGrpSpPr/>
          <p:nvPr/>
        </p:nvGrpSpPr>
        <p:grpSpPr>
          <a:xfrm>
            <a:off x="-2967" y="901945"/>
            <a:ext cx="4370363" cy="3604618"/>
            <a:chOff x="3063711" y="1640263"/>
            <a:chExt cx="1882471" cy="1440000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063711" y="1640263"/>
              <a:ext cx="1882471" cy="14400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24B6EE-039D-4BE3-9CD9-8A38CFB4E9FA}"/>
                </a:ext>
              </a:extLst>
            </p:cNvPr>
            <p:cNvSpPr txBox="1"/>
            <p:nvPr/>
          </p:nvSpPr>
          <p:spPr>
            <a:xfrm>
              <a:off x="3337680" y="2253697"/>
              <a:ext cx="429992" cy="1615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8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778099B-55A9-4707-AAC0-83E3FFD2A991}"/>
              </a:ext>
            </a:extLst>
          </p:cNvPr>
          <p:cNvGrpSpPr/>
          <p:nvPr/>
        </p:nvGrpSpPr>
        <p:grpSpPr>
          <a:xfrm>
            <a:off x="4421749" y="901945"/>
            <a:ext cx="4581575" cy="3604617"/>
            <a:chOff x="7819344" y="1640262"/>
            <a:chExt cx="1654594" cy="1440000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819344" y="1640262"/>
              <a:ext cx="1654594" cy="14400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7A5D5FD-C355-410E-828D-A84F2B62BF61}"/>
                </a:ext>
              </a:extLst>
            </p:cNvPr>
            <p:cNvSpPr txBox="1"/>
            <p:nvPr/>
          </p:nvSpPr>
          <p:spPr>
            <a:xfrm>
              <a:off x="8038500" y="2275673"/>
              <a:ext cx="334650" cy="1615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8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4EB026A8-FB25-284E-9FF4-36E434951F5A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1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7ED65B8-E4F6-3941-9155-8D25E454D9AD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7D06E7A-4A88-D747-AF83-E9F6EE801DC4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46445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A90DCACA-069B-46B9-B94C-47B3862127EB}"/>
              </a:ext>
            </a:extLst>
          </p:cNvPr>
          <p:cNvGrpSpPr/>
          <p:nvPr/>
        </p:nvGrpSpPr>
        <p:grpSpPr>
          <a:xfrm>
            <a:off x="4650655" y="932816"/>
            <a:ext cx="3684644" cy="3514040"/>
            <a:chOff x="7383290" y="1741251"/>
            <a:chExt cx="2422191" cy="2880000"/>
          </a:xfrm>
        </p:grpSpPr>
        <p:pic>
          <p:nvPicPr>
            <p:cNvPr id="2" name="Grafik 1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383290" y="1741251"/>
              <a:ext cx="2422191" cy="28800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9E0FFEF-FAFE-4368-A373-0F2EB79604F0}"/>
                </a:ext>
              </a:extLst>
            </p:cNvPr>
            <p:cNvSpPr txBox="1"/>
            <p:nvPr/>
          </p:nvSpPr>
          <p:spPr>
            <a:xfrm>
              <a:off x="7683975" y="2816577"/>
              <a:ext cx="64794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52D8934-60B5-40D4-8863-660E2C1F2BDA}"/>
              </a:ext>
            </a:extLst>
          </p:cNvPr>
          <p:cNvGrpSpPr/>
          <p:nvPr/>
        </p:nvGrpSpPr>
        <p:grpSpPr>
          <a:xfrm>
            <a:off x="482171" y="932816"/>
            <a:ext cx="4106909" cy="3514041"/>
            <a:chOff x="1673153" y="1741251"/>
            <a:chExt cx="2597290" cy="2880000"/>
          </a:xfrm>
        </p:grpSpPr>
        <p:pic>
          <p:nvPicPr>
            <p:cNvPr id="3" name="Grafik 2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73153" y="1741251"/>
              <a:ext cx="2597290" cy="28800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5D972D-ACAD-4BE9-9DF6-C166779A0BC7}"/>
                </a:ext>
              </a:extLst>
            </p:cNvPr>
            <p:cNvSpPr txBox="1"/>
            <p:nvPr/>
          </p:nvSpPr>
          <p:spPr>
            <a:xfrm>
              <a:off x="1884887" y="2851496"/>
              <a:ext cx="784486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2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6B617B82-2BE0-3341-BB40-1E583E05614A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2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2EC66C4-D9FE-4040-BC07-E8B4282FD4A1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E14FD58-A68F-6F41-BE67-359999AC0B22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72862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69B80EA-C797-4191-9674-F3C63C4C9215}"/>
              </a:ext>
            </a:extLst>
          </p:cNvPr>
          <p:cNvGrpSpPr/>
          <p:nvPr/>
        </p:nvGrpSpPr>
        <p:grpSpPr>
          <a:xfrm>
            <a:off x="4218331" y="1029015"/>
            <a:ext cx="4661638" cy="3650681"/>
            <a:chOff x="7646125" y="2490281"/>
            <a:chExt cx="2659925" cy="2120630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646125" y="2490281"/>
              <a:ext cx="2659925" cy="212063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F070EB3-1A7D-4044-84B0-81AFC8D3BAD4}"/>
                </a:ext>
              </a:extLst>
            </p:cNvPr>
            <p:cNvSpPr txBox="1"/>
            <p:nvPr/>
          </p:nvSpPr>
          <p:spPr>
            <a:xfrm>
              <a:off x="8688151" y="3144065"/>
              <a:ext cx="489022" cy="23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6F14013-B880-4DB7-8BA2-BFAF285B7794}"/>
                </a:ext>
              </a:extLst>
            </p:cNvPr>
            <p:cNvSpPr txBox="1"/>
            <p:nvPr/>
          </p:nvSpPr>
          <p:spPr>
            <a:xfrm>
              <a:off x="8591874" y="3432534"/>
              <a:ext cx="510016" cy="23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4EEF895-B035-46F5-A7D9-7FB6FA9C746A}"/>
              </a:ext>
            </a:extLst>
          </p:cNvPr>
          <p:cNvGrpSpPr/>
          <p:nvPr/>
        </p:nvGrpSpPr>
        <p:grpSpPr>
          <a:xfrm>
            <a:off x="206948" y="1028242"/>
            <a:ext cx="3951966" cy="3651455"/>
            <a:chOff x="2943498" y="2491292"/>
            <a:chExt cx="2542902" cy="2120631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943498" y="2491292"/>
              <a:ext cx="2542902" cy="212063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80D29BA-4F8A-45DC-AF24-B7EC036FAAE1}"/>
                </a:ext>
              </a:extLst>
            </p:cNvPr>
            <p:cNvSpPr txBox="1"/>
            <p:nvPr/>
          </p:nvSpPr>
          <p:spPr>
            <a:xfrm>
              <a:off x="3924395" y="3142004"/>
              <a:ext cx="485120" cy="23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AEFCA17-4B4F-44C0-9CE9-C74D6EA51FD8}"/>
                </a:ext>
              </a:extLst>
            </p:cNvPr>
            <p:cNvSpPr txBox="1"/>
            <p:nvPr/>
          </p:nvSpPr>
          <p:spPr>
            <a:xfrm>
              <a:off x="3853786" y="3473413"/>
              <a:ext cx="575813" cy="23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2</a:t>
              </a:r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853D0E4D-85C5-2541-A58A-5D0D48865F7A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3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D9D0609-1050-1743-9C3E-BECE1512E810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6C53543-D6D7-634F-82D8-C3794FB412DA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443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303F4998-3601-4696-B428-3903FAB4D410}"/>
              </a:ext>
            </a:extLst>
          </p:cNvPr>
          <p:cNvGrpSpPr/>
          <p:nvPr/>
        </p:nvGrpSpPr>
        <p:grpSpPr>
          <a:xfrm>
            <a:off x="4499652" y="1123030"/>
            <a:ext cx="3859510" cy="3447656"/>
            <a:chOff x="7286624" y="2609850"/>
            <a:chExt cx="2209801" cy="2305050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286624" y="2609850"/>
              <a:ext cx="2209801" cy="230505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8E00E8-7E53-42CE-8805-875A663E49C6}"/>
                </a:ext>
              </a:extLst>
            </p:cNvPr>
            <p:cNvSpPr txBox="1"/>
            <p:nvPr/>
          </p:nvSpPr>
          <p:spPr>
            <a:xfrm>
              <a:off x="7451618" y="3494893"/>
              <a:ext cx="459756" cy="258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8CC1BB09-AA4C-4606-BD06-D0E1E8A101E0}"/>
              </a:ext>
            </a:extLst>
          </p:cNvPr>
          <p:cNvGrpSpPr/>
          <p:nvPr/>
        </p:nvGrpSpPr>
        <p:grpSpPr>
          <a:xfrm>
            <a:off x="503946" y="1078480"/>
            <a:ext cx="3711564" cy="3536684"/>
            <a:chOff x="4019550" y="2428875"/>
            <a:chExt cx="1666875" cy="1562099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019550" y="2428875"/>
              <a:ext cx="1666875" cy="156209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5107704-F60C-46DA-BB28-2F46D3D1F1BA}"/>
                </a:ext>
              </a:extLst>
            </p:cNvPr>
            <p:cNvSpPr txBox="1"/>
            <p:nvPr/>
          </p:nvSpPr>
          <p:spPr>
            <a:xfrm>
              <a:off x="4094350" y="3029869"/>
              <a:ext cx="318565" cy="175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8902356D-99A9-5E4B-827E-DC68EE5871B3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4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C5405D3-2D51-0145-9D3B-6BBBC8C195F1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C7F000F-AA32-3344-9ECD-FABE048E76B7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21352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3C96EED0-827B-4AA3-8781-EB3506E3C797}"/>
              </a:ext>
            </a:extLst>
          </p:cNvPr>
          <p:cNvGrpSpPr/>
          <p:nvPr/>
        </p:nvGrpSpPr>
        <p:grpSpPr>
          <a:xfrm>
            <a:off x="4497189" y="864883"/>
            <a:ext cx="3703265" cy="3683873"/>
            <a:chOff x="8059714" y="2686048"/>
            <a:chExt cx="1208111" cy="1714501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086724" y="2686048"/>
              <a:ext cx="1181101" cy="1714501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0E2E4C0-FCE3-4252-8F69-C91721DF8939}"/>
                </a:ext>
              </a:extLst>
            </p:cNvPr>
            <p:cNvSpPr txBox="1"/>
            <p:nvPr/>
          </p:nvSpPr>
          <p:spPr>
            <a:xfrm flipH="1">
              <a:off x="8059714" y="3348819"/>
              <a:ext cx="275772" cy="192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1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7283642F-4BD6-451F-B2FD-DE845EAC6084}"/>
              </a:ext>
            </a:extLst>
          </p:cNvPr>
          <p:cNvGrpSpPr/>
          <p:nvPr/>
        </p:nvGrpSpPr>
        <p:grpSpPr>
          <a:xfrm>
            <a:off x="396840" y="867981"/>
            <a:ext cx="3713666" cy="3672552"/>
            <a:chOff x="3282921" y="2686049"/>
            <a:chExt cx="1336704" cy="1714501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286124" y="2686049"/>
              <a:ext cx="1333501" cy="171450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E08656C-07E1-42A9-A287-870E39D747F7}"/>
                </a:ext>
              </a:extLst>
            </p:cNvPr>
            <p:cNvSpPr txBox="1"/>
            <p:nvPr/>
          </p:nvSpPr>
          <p:spPr>
            <a:xfrm>
              <a:off x="3282921" y="3349417"/>
              <a:ext cx="336717" cy="192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1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F88EC6CA-3665-CC45-BCB8-1D809570F5D8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5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193EA0C-7B0D-7444-95E4-296658B3D063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805EA51-938B-1141-A77B-974DDE2C46F0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75986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9F0EE836-7B67-49D9-810E-24D7285C7EE9}"/>
              </a:ext>
            </a:extLst>
          </p:cNvPr>
          <p:cNvGrpSpPr/>
          <p:nvPr/>
        </p:nvGrpSpPr>
        <p:grpSpPr>
          <a:xfrm>
            <a:off x="443438" y="867979"/>
            <a:ext cx="3625697" cy="3672551"/>
            <a:chOff x="2819400" y="3000375"/>
            <a:chExt cx="1743075" cy="178117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819400" y="3000375"/>
              <a:ext cx="1743075" cy="178117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71F9BE4-A6F1-44EB-8CA3-C091DC5097F7}"/>
                </a:ext>
              </a:extLst>
            </p:cNvPr>
            <p:cNvSpPr txBox="1"/>
            <p:nvPr/>
          </p:nvSpPr>
          <p:spPr>
            <a:xfrm>
              <a:off x="2822868" y="3753995"/>
              <a:ext cx="361440" cy="199866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/>
                  <a:cs typeface="Arial"/>
                </a:rPr>
                <a:t>L3</a:t>
              </a:r>
              <a:endParaRPr lang="en-SG" sz="1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8AF8B33-11B2-48FB-B46A-416E4AF16FAE}"/>
              </a:ext>
            </a:extLst>
          </p:cNvPr>
          <p:cNvGrpSpPr/>
          <p:nvPr/>
        </p:nvGrpSpPr>
        <p:grpSpPr>
          <a:xfrm>
            <a:off x="4655527" y="876198"/>
            <a:ext cx="3454370" cy="3649903"/>
            <a:chOff x="7629527" y="3067050"/>
            <a:chExt cx="1638298" cy="19907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629527" y="3067050"/>
              <a:ext cx="1638298" cy="199072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05E8579-3587-4BBF-864A-3A470A7E5FD2}"/>
                </a:ext>
              </a:extLst>
            </p:cNvPr>
            <p:cNvSpPr txBox="1"/>
            <p:nvPr/>
          </p:nvSpPr>
          <p:spPr>
            <a:xfrm>
              <a:off x="7632167" y="3876617"/>
              <a:ext cx="324789" cy="223379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/>
                  <a:cs typeface="Arial"/>
                </a:rPr>
                <a:t>L3</a:t>
              </a:r>
              <a:endParaRPr lang="en-SG" sz="1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A7A27EE6-9BB3-C949-818C-43C029A3A4A0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6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7DBCC61-08AE-EE4C-8C56-4DAF2F43C921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C1B4504-A350-2E4D-994A-F9DA1F82B5CB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51470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85A6DC51-7DAD-447D-A38D-CC0F6D647188}"/>
              </a:ext>
            </a:extLst>
          </p:cNvPr>
          <p:cNvGrpSpPr/>
          <p:nvPr/>
        </p:nvGrpSpPr>
        <p:grpSpPr>
          <a:xfrm>
            <a:off x="4314765" y="901945"/>
            <a:ext cx="3976250" cy="3910317"/>
            <a:chOff x="7991474" y="2600325"/>
            <a:chExt cx="1676401" cy="1962150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991474" y="2600325"/>
              <a:ext cx="1676401" cy="196215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67C04FE-34CF-4065-A42F-0A794FAB28B2}"/>
                </a:ext>
              </a:extLst>
            </p:cNvPr>
            <p:cNvSpPr txBox="1"/>
            <p:nvPr/>
          </p:nvSpPr>
          <p:spPr>
            <a:xfrm>
              <a:off x="8094586" y="3286982"/>
              <a:ext cx="359375" cy="220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5F79AB6-F056-43FB-921C-4CA97C3BB21F}"/>
              </a:ext>
            </a:extLst>
          </p:cNvPr>
          <p:cNvGrpSpPr/>
          <p:nvPr/>
        </p:nvGrpSpPr>
        <p:grpSpPr>
          <a:xfrm>
            <a:off x="379017" y="901946"/>
            <a:ext cx="3740051" cy="3910317"/>
            <a:chOff x="4571999" y="2917584"/>
            <a:chExt cx="1473653" cy="157162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71999" y="2917584"/>
              <a:ext cx="1473653" cy="157162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D84D4B6-13F0-481F-9E31-FC26155AC428}"/>
                </a:ext>
              </a:extLst>
            </p:cNvPr>
            <p:cNvSpPr txBox="1"/>
            <p:nvPr/>
          </p:nvSpPr>
          <p:spPr>
            <a:xfrm>
              <a:off x="4697710" y="3472302"/>
              <a:ext cx="299129" cy="176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SG" sz="1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AD19502F-6190-1B47-9CE0-4F804B14171E}"/>
              </a:ext>
            </a:extLst>
          </p:cNvPr>
          <p:cNvSpPr/>
          <p:nvPr/>
        </p:nvSpPr>
        <p:spPr>
          <a:xfrm>
            <a:off x="321058" y="53369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07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3FF030D-5CAA-8744-AF3E-62C7CFB1CB6F}"/>
              </a:ext>
            </a:extLst>
          </p:cNvPr>
          <p:cNvSpPr/>
          <p:nvPr/>
        </p:nvSpPr>
        <p:spPr>
          <a:xfrm>
            <a:off x="1371053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0FDD22D-FE33-EB46-A857-A6A54F9B90A4}"/>
              </a:ext>
            </a:extLst>
          </p:cNvPr>
          <p:cNvSpPr/>
          <p:nvPr/>
        </p:nvSpPr>
        <p:spPr>
          <a:xfrm>
            <a:off x="5901375" y="477657"/>
            <a:ext cx="162232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6569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</TotalTime>
  <Words>391</Words>
  <Application>Microsoft Office PowerPoint</Application>
  <PresentationFormat>Custom</PresentationFormat>
  <Paragraphs>144</Paragraphs>
  <Slides>18</Slides>
  <Notes>1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linikum rechts der Isa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acs</dc:creator>
  <cp:lastModifiedBy>PhD - Rayudu Nithin Manohar Chowdary</cp:lastModifiedBy>
  <cp:revision>236</cp:revision>
  <dcterms:created xsi:type="dcterms:W3CDTF">2021-01-25T03:42:22Z</dcterms:created>
  <dcterms:modified xsi:type="dcterms:W3CDTF">2021-01-27T01:47:14Z</dcterms:modified>
</cp:coreProperties>
</file>